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00" r:id="rId2"/>
    <p:sldId id="303" r:id="rId3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989" autoAdjust="0"/>
    <p:restoredTop sz="95517" autoAdjust="0"/>
  </p:normalViewPr>
  <p:slideViewPr>
    <p:cSldViewPr>
      <p:cViewPr varScale="1">
        <p:scale>
          <a:sx n="78" d="100"/>
          <a:sy n="78" d="100"/>
        </p:scale>
        <p:origin x="-1668" y="-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ADE111-F953-42CB-8298-98C6B28AE735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962B18-DEF8-4269-ADF4-F3441CBDB8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84261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78717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59281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77179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baseline="0">
                <a:latin typeface="Times New Roman" panose="02020603050405020304" pitchFamily="18" charset="0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baseline="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  <a:lvl2pPr>
              <a:defRPr baseline="0">
                <a:latin typeface="Times New Roman" panose="02020603050405020304" pitchFamily="18" charset="0"/>
                <a:cs typeface="Times New Roman" panose="02020603050405020304" pitchFamily="18" charset="0"/>
              </a:defRPr>
            </a:lvl2pPr>
            <a:lvl3pPr>
              <a:defRPr baseline="0">
                <a:latin typeface="Times New Roman" panose="02020603050405020304" pitchFamily="18" charset="0"/>
                <a:cs typeface="Times New Roman" panose="02020603050405020304" pitchFamily="18" charset="0"/>
              </a:defRPr>
            </a:lvl3pPr>
            <a:lvl4pPr>
              <a:defRPr baseline="0">
                <a:latin typeface="Times New Roman" panose="02020603050405020304" pitchFamily="18" charset="0"/>
                <a:cs typeface="Times New Roman" panose="02020603050405020304" pitchFamily="18" charset="0"/>
              </a:defRPr>
            </a:lvl4pPr>
            <a:lvl5pPr>
              <a:defRPr baseline="0">
                <a:latin typeface="Times New Roman" panose="02020603050405020304" pitchFamily="18" charset="0"/>
                <a:cs typeface="Times New Roman" panose="02020603050405020304" pitchFamily="18" charset="0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35785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5356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567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5117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5995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84541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1783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9277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6750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4694" y="2735796"/>
            <a:ext cx="5480202" cy="3348372"/>
          </a:xfrm>
        </p:spPr>
      </p:pic>
      <p:sp>
        <p:nvSpPr>
          <p:cNvPr id="7" name="テキスト ボックス 6"/>
          <p:cNvSpPr txBox="1"/>
          <p:nvPr/>
        </p:nvSpPr>
        <p:spPr>
          <a:xfrm>
            <a:off x="1754814" y="2734066"/>
            <a:ext cx="97210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RB-65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4671138" y="2746470"/>
            <a:ext cx="97210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I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862826" y="4355977"/>
            <a:ext cx="97210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SOFA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4655848" y="4355977"/>
            <a:ext cx="97210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S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214754" y="4113602"/>
            <a:ext cx="1944216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vivors            Non-survivors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008876" y="4155254"/>
            <a:ext cx="1944216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vivors            Non-survivors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268760" y="5864877"/>
            <a:ext cx="1944216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rvivors            Non-survivors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4077072" y="5849822"/>
            <a:ext cx="1944216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vivors            Non-survivors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正方形/長方形 14"/>
          <p:cNvSpPr/>
          <p:nvPr/>
        </p:nvSpPr>
        <p:spPr>
          <a:xfrm>
            <a:off x="3212976" y="5864877"/>
            <a:ext cx="594066" cy="27329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350"/>
          </a:p>
        </p:txBody>
      </p:sp>
      <p:sp>
        <p:nvSpPr>
          <p:cNvPr id="16" name="正方形/長方形 15"/>
          <p:cNvSpPr/>
          <p:nvPr/>
        </p:nvSpPr>
        <p:spPr>
          <a:xfrm>
            <a:off x="674695" y="2284808"/>
            <a:ext cx="118813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</a:t>
            </a:r>
            <a:r>
              <a: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-a</a:t>
            </a:r>
            <a:r>
              <a:rPr lang="ja-JP" altLang="en-US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285637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グループ化 16"/>
          <p:cNvGrpSpPr/>
          <p:nvPr/>
        </p:nvGrpSpPr>
        <p:grpSpPr>
          <a:xfrm>
            <a:off x="674694" y="2843808"/>
            <a:ext cx="5454606" cy="3240360"/>
            <a:chOff x="899592" y="1124744"/>
            <a:chExt cx="7272808" cy="4047793"/>
          </a:xfrm>
        </p:grpSpPr>
        <p:pic>
          <p:nvPicPr>
            <p:cNvPr id="5" name="図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9592" y="1124744"/>
              <a:ext cx="7272808" cy="3960440"/>
            </a:xfrm>
            <a:prstGeom prst="rect">
              <a:avLst/>
            </a:prstGeom>
          </p:spPr>
        </p:pic>
        <p:sp>
          <p:nvSpPr>
            <p:cNvPr id="3" name="テキスト ボックス 2"/>
            <p:cNvSpPr txBox="1"/>
            <p:nvPr/>
          </p:nvSpPr>
          <p:spPr>
            <a:xfrm>
              <a:off x="2339752" y="1131164"/>
              <a:ext cx="1296144" cy="34602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URB-65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6228184" y="1160755"/>
              <a:ext cx="1296144" cy="34602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SI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2380671" y="3098393"/>
              <a:ext cx="1296144" cy="34602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qSOFA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6228184" y="3125579"/>
              <a:ext cx="1296144" cy="34602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RS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1743671" y="2817801"/>
              <a:ext cx="2592288" cy="3171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n-ICU                      ICU</a:t>
              </a:r>
              <a:endParaRPr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正方形/長方形 12"/>
            <p:cNvSpPr/>
            <p:nvPr/>
          </p:nvSpPr>
          <p:spPr>
            <a:xfrm>
              <a:off x="4387874" y="4808141"/>
              <a:ext cx="792088" cy="36439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5332439" y="4667195"/>
              <a:ext cx="2592288" cy="3171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n-ICU                      ICU</a:t>
              </a:r>
              <a:endParaRPr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5332439" y="2805937"/>
              <a:ext cx="2592288" cy="3171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n-ICU                      ICU</a:t>
              </a:r>
              <a:endParaRPr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1807027" y="4685795"/>
              <a:ext cx="2592288" cy="3171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n-ICU                      ICU</a:t>
              </a:r>
              <a:endParaRPr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8" name="正方形/長方形 17"/>
          <p:cNvSpPr/>
          <p:nvPr/>
        </p:nvSpPr>
        <p:spPr>
          <a:xfrm>
            <a:off x="620689" y="2330349"/>
            <a:ext cx="113412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</a:t>
            </a:r>
            <a:r>
              <a: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-b</a:t>
            </a:r>
            <a:r>
              <a:rPr lang="ja-JP" altLang="en-US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836712" y="7020272"/>
            <a:ext cx="49685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836712" y="6444208"/>
            <a:ext cx="547260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bbreviations</a:t>
            </a:r>
            <a:r>
              <a:rPr lang="en-US" dirty="0"/>
              <a:t>: </a:t>
            </a:r>
            <a:r>
              <a:rPr lang="en-US" dirty="0" smtClean="0"/>
              <a:t>CURB-65 = Confusion</a:t>
            </a:r>
            <a:r>
              <a:rPr lang="en-US" dirty="0"/>
              <a:t>, Urea, Respiratory Rate, Blood Pressure and Age; </a:t>
            </a:r>
            <a:r>
              <a:rPr lang="en-US" dirty="0" smtClean="0"/>
              <a:t>ICU</a:t>
            </a:r>
            <a:r>
              <a:rPr lang="en-US" dirty="0"/>
              <a:t> = </a:t>
            </a:r>
            <a:r>
              <a:rPr lang="en-US" dirty="0" smtClean="0"/>
              <a:t>intensive </a:t>
            </a:r>
            <a:r>
              <a:rPr lang="en-US" dirty="0"/>
              <a:t>care unit; </a:t>
            </a:r>
            <a:r>
              <a:rPr lang="en-US" dirty="0" smtClean="0"/>
              <a:t>PSI</a:t>
            </a:r>
            <a:r>
              <a:rPr lang="en-US" dirty="0"/>
              <a:t> = </a:t>
            </a:r>
            <a:r>
              <a:rPr lang="en-US" dirty="0" smtClean="0"/>
              <a:t>Pneumonia </a:t>
            </a:r>
            <a:r>
              <a:rPr lang="en-US" dirty="0"/>
              <a:t>Severity Index; </a:t>
            </a:r>
            <a:r>
              <a:rPr lang="en-US" dirty="0" err="1" smtClean="0"/>
              <a:t>qSOFA</a:t>
            </a:r>
            <a:r>
              <a:rPr lang="en-US" dirty="0"/>
              <a:t> = </a:t>
            </a:r>
            <a:r>
              <a:rPr lang="en-US" dirty="0" smtClean="0"/>
              <a:t>quick </a:t>
            </a:r>
            <a:r>
              <a:rPr lang="en-US" dirty="0"/>
              <a:t>Sequential (Sepsis-related) Organ Failure Assessment; </a:t>
            </a:r>
            <a:r>
              <a:rPr lang="en-US" dirty="0" smtClean="0"/>
              <a:t>SIRS</a:t>
            </a:r>
            <a:r>
              <a:rPr lang="en-US" dirty="0"/>
              <a:t> = </a:t>
            </a:r>
            <a:r>
              <a:rPr lang="en-US" dirty="0" smtClean="0"/>
              <a:t>systemic inflammatory response syndrom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240523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26</TotalTime>
  <Words>76</Words>
  <Application>Microsoft Office PowerPoint</Application>
  <PresentationFormat>On-screen Show (4:3)</PresentationFormat>
  <Paragraphs>19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​​テーマ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時岡　史明</dc:creator>
  <cp:lastModifiedBy>Calumpang, Mario Jade</cp:lastModifiedBy>
  <cp:revision>221</cp:revision>
  <dcterms:created xsi:type="dcterms:W3CDTF">2017-03-22T06:45:40Z</dcterms:created>
  <dcterms:modified xsi:type="dcterms:W3CDTF">2018-07-09T03:37:34Z</dcterms:modified>
</cp:coreProperties>
</file>